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48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3200" b="1" dirty="0">
                <a:solidFill>
                  <a:schemeClr val="bg1"/>
                </a:solidFill>
              </a:rPr>
              <a:t>The role of nesfatin-1 in kidney diseas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11768182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r>
              <a:rPr lang="en-GB" dirty="0">
                <a:solidFill>
                  <a:srgbClr val="003969"/>
                </a:solidFill>
              </a:rPr>
              <a:t>1. Nesfatin-1 is a recently discovered protein with a pleiotropic function on various organs, including kidneys.</a:t>
            </a:r>
            <a:br>
              <a:rPr lang="en-GB" dirty="0">
                <a:solidFill>
                  <a:srgbClr val="003969"/>
                </a:solidFill>
              </a:rPr>
            </a:br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2. Nesfatin-1 is a molecule with antiapoptotic, antihyperglycemic, antioxidative and anorectic features.</a:t>
            </a:r>
            <a:br>
              <a:rPr lang="en-GB" dirty="0">
                <a:solidFill>
                  <a:srgbClr val="003969"/>
                </a:solidFill>
              </a:rPr>
            </a:br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The levels of nesfatin-1 were increased in patients with diabetic kidney disease (DKD). Hence it was suggested that nesfatin-1 might act as an early DKD marker.</a:t>
            </a:r>
            <a:br>
              <a:rPr lang="en-GB" dirty="0">
                <a:solidFill>
                  <a:srgbClr val="003969"/>
                </a:solidFill>
              </a:rPr>
            </a:br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4. The potential protective function of nesfatin-1 against inflammation, oxidative stress, fibrosis and apoptosis in kidney tissues are described in several studies.</a:t>
            </a:r>
            <a:br>
              <a:rPr lang="en-GB" dirty="0">
                <a:solidFill>
                  <a:srgbClr val="003969"/>
                </a:solidFill>
              </a:rPr>
            </a:br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5. Alternatively, as reported in the literature, a positive correlation between blood pressure elevation and </a:t>
            </a:r>
            <a:br>
              <a:rPr lang="en-GB" dirty="0">
                <a:solidFill>
                  <a:srgbClr val="003969"/>
                </a:solidFill>
              </a:rPr>
            </a:br>
            <a:r>
              <a:rPr lang="en-GB" dirty="0">
                <a:solidFill>
                  <a:srgbClr val="003969"/>
                </a:solidFill>
              </a:rPr>
              <a:t>nesfatin-1 levels was noted.</a:t>
            </a:r>
            <a:br>
              <a:rPr lang="en-GB" dirty="0">
                <a:solidFill>
                  <a:srgbClr val="003969"/>
                </a:solidFill>
              </a:rPr>
            </a:br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6. Moreover, nesfatin-1 might exert influence on renal cell carcinoma progression and invasion of cancerous cell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deńska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Nesfatin-1 shows a considerable potential </a:t>
            </a:r>
            <a:br>
              <a:rPr lang="en-GB" dirty="0">
                <a:solidFill>
                  <a:schemeClr val="bg1"/>
                </a:solidFill>
              </a:rPr>
            </a:br>
            <a:r>
              <a:rPr lang="en-GB" dirty="0">
                <a:solidFill>
                  <a:schemeClr val="bg1"/>
                </a:solidFill>
              </a:rPr>
              <a:t>for acting as a prognostic marker or a defensive factor for kidney diseases. Further investigation, especially in the pediatric population, is required.</a:t>
            </a:r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91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10-16T18:59:55Z</dcterms:modified>
</cp:coreProperties>
</file>